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86575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0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002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777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3214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957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715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601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7978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639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4848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859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751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16EDE-FA82-4F9C-89DE-DD65B7EE1C14}" type="datetimeFigureOut">
              <a:rPr lang="en-GB" smtClean="0"/>
              <a:t>1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C9A55-F051-4827-B5AA-8F385F53C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84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B504D622-3CFB-85BB-647D-257AF3FD02BB}"/>
              </a:ext>
            </a:extLst>
          </p:cNvPr>
          <p:cNvSpPr txBox="1"/>
          <p:nvPr/>
        </p:nvSpPr>
        <p:spPr>
          <a:xfrm>
            <a:off x="481010" y="6265944"/>
            <a:ext cx="5895978" cy="1516762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sz="1200" b="1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uctus venosus </a:t>
            </a:r>
            <a:r>
              <a:rPr lang="en-GB" sz="1200" b="1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ulsatility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ex as a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al predictor of adverse perinatal outcomes in the EVERREST cohort.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ociations with fetal cord hemopexin levels at delivery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;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with a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me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andling composite measure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uskall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llis; NS)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5">
            <a:extLst>
              <a:ext uri="{FF2B5EF4-FFF2-40B4-BE49-F238E27FC236}">
                <a16:creationId xmlns:a16="http://schemas.microsoft.com/office/drawing/2014/main" id="{EBD731FC-285B-20DD-E5A7-0FEB8A30C58B}"/>
              </a:ext>
            </a:extLst>
          </p:cNvPr>
          <p:cNvGraphicFramePr/>
          <p:nvPr/>
        </p:nvGraphicFramePr>
        <p:xfrm>
          <a:off x="326075" y="794083"/>
          <a:ext cx="6205849" cy="52191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877050" imgH="5781675" progId="">
                  <p:embed/>
                </p:oleObj>
              </mc:Choice>
              <mc:Fallback>
                <p:oleObj name="Prism 9" r:id="rId2" imgW="6877050" imgH="5781675" progId="">
                  <p:embed/>
                  <p:pic>
                    <p:nvPicPr>
                      <p:cNvPr id="3" name="Object 5">
                        <a:extLst>
                          <a:ext uri="{FF2B5EF4-FFF2-40B4-BE49-F238E27FC236}">
                            <a16:creationId xmlns:a16="http://schemas.microsoft.com/office/drawing/2014/main" id="{EBD731FC-285B-20DD-E5A7-0FEB8A30C5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075" y="794083"/>
                        <a:ext cx="6205849" cy="5219111"/>
                      </a:xfrm>
                      <a:prstGeom prst="rect">
                        <a:avLst/>
                      </a:prstGeom>
                      <a:noFill/>
                      <a:ln cap="flat"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9</TotalTime>
  <Words>4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ownbill</dc:creator>
  <cp:lastModifiedBy>Paul Brownbill</cp:lastModifiedBy>
  <cp:revision>7</cp:revision>
  <cp:lastPrinted>2024-09-11T15:28:25Z</cp:lastPrinted>
  <dcterms:created xsi:type="dcterms:W3CDTF">2024-03-17T16:39:08Z</dcterms:created>
  <dcterms:modified xsi:type="dcterms:W3CDTF">2024-09-11T16:48:40Z</dcterms:modified>
</cp:coreProperties>
</file>